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99AD0C-6A8D-4F2F-949E-AD49B3788D2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EC8A06-195D-4B78-9213-2C8665B35B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BD2092-CB04-4941-AA6F-9219E30F06C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26EB67-5154-4477-B4B3-BF8725C6C6A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15BB66-1089-4779-81B4-E3FD1052CF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C47AC9-34E2-47E3-B28C-A79FFE7D37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B07E9D-2D25-49F3-B2B2-3F5764D690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53043C-E6F9-4292-9722-262AFC24C0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B1FA51-E303-4277-9FF2-5107CEBEFD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BB19C6-2A71-40F3-9575-CBA2161BD9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98E521-8396-471F-B031-D04088D69A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AB140B-B3E7-4236-BDEE-7A16A93966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9AE826D-1E0B-4D6A-A26F-885960AEB7B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965160" y="1163520"/>
            <a:ext cx="7223040" cy="4538880"/>
            <a:chOff x="965160" y="1163520"/>
            <a:chExt cx="7223040" cy="4538880"/>
          </a:xfrm>
        </p:grpSpPr>
        <p:sp>
          <p:nvSpPr>
            <p:cNvPr id="42" name=""/>
            <p:cNvSpPr/>
            <p:nvPr/>
          </p:nvSpPr>
          <p:spPr>
            <a:xfrm>
              <a:off x="965160" y="1163520"/>
              <a:ext cx="7213680" cy="45291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1630440" y="1335240"/>
              <a:ext cx="5883120" cy="3919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1630440" y="1335240"/>
              <a:ext cx="5875200" cy="39099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965160" y="1163520"/>
              <a:ext cx="7223040" cy="57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965160" y="5635800"/>
              <a:ext cx="7223040" cy="66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965160" y="1220760"/>
              <a:ext cx="57240" cy="4415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8121600" y="1220760"/>
              <a:ext cx="66600" cy="4415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542840" y="544500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1630440" y="5245200"/>
              <a:ext cx="587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1630440" y="524520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1533600" y="5321160"/>
              <a:ext cx="2415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-0.1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3100320" y="524520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003480" y="5321160"/>
              <a:ext cx="2415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-0.0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806560" y="5245200"/>
              <a:ext cx="0" cy="38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513160" y="5245200"/>
              <a:ext cx="0" cy="38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217600" y="5245200"/>
              <a:ext cx="0" cy="38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1924200" y="5245200"/>
              <a:ext cx="0" cy="38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4572000" y="524520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4494240" y="5321160"/>
              <a:ext cx="2034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0.0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4278240" y="5245200"/>
              <a:ext cx="0" cy="38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3983040" y="5245200"/>
              <a:ext cx="0" cy="38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3689280" y="5245200"/>
              <a:ext cx="0" cy="38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3395520" y="5245200"/>
              <a:ext cx="0" cy="38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6033960" y="524520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5956200" y="5321160"/>
              <a:ext cx="2034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0.1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5738760" y="5245200"/>
              <a:ext cx="0" cy="38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5445000" y="5245200"/>
              <a:ext cx="0" cy="38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5151600" y="5245200"/>
              <a:ext cx="0" cy="38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4856040" y="5245200"/>
              <a:ext cx="0" cy="38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7505640" y="524520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7427880" y="5321160"/>
              <a:ext cx="2034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0.1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7210440" y="5245200"/>
              <a:ext cx="0" cy="38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6916680" y="5245200"/>
              <a:ext cx="0" cy="38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6621480" y="5245200"/>
              <a:ext cx="0" cy="38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6327720" y="5245200"/>
              <a:ext cx="0" cy="38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1229760" y="322884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 flipV="1">
              <a:off x="1630440" y="1334880"/>
              <a:ext cx="0" cy="3909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 flipH="1">
              <a:off x="1554120" y="5245200"/>
              <a:ext cx="76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1361880" y="5178600"/>
              <a:ext cx="2415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-0.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 flipH="1">
              <a:off x="1554120" y="4275000"/>
              <a:ext cx="76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1361880" y="4208400"/>
              <a:ext cx="2415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-0.1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flipH="1">
              <a:off x="1592280" y="4465800"/>
              <a:ext cx="38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 flipH="1">
              <a:off x="1592280" y="4665600"/>
              <a:ext cx="38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 flipH="1">
              <a:off x="1592280" y="4856040"/>
              <a:ext cx="38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 flipH="1">
              <a:off x="1592280" y="5054760"/>
              <a:ext cx="38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 flipH="1">
              <a:off x="1554120" y="3295800"/>
              <a:ext cx="76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1361880" y="3228840"/>
              <a:ext cx="2415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-0.0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 flipH="1">
              <a:off x="1592280" y="3484440"/>
              <a:ext cx="38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 flipH="1">
              <a:off x="1592280" y="3684600"/>
              <a:ext cx="38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flipH="1">
              <a:off x="1592280" y="3875040"/>
              <a:ext cx="38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 flipH="1">
              <a:off x="1592280" y="4075200"/>
              <a:ext cx="38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 flipH="1">
              <a:off x="1554120" y="2314440"/>
              <a:ext cx="76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1390680" y="2247840"/>
              <a:ext cx="2034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0.0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 flipH="1">
              <a:off x="1592280" y="2505240"/>
              <a:ext cx="38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 flipH="1">
              <a:off x="1592280" y="2705040"/>
              <a:ext cx="38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 flipH="1">
              <a:off x="1592280" y="2905200"/>
              <a:ext cx="38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 flipH="1">
              <a:off x="1592280" y="3095640"/>
              <a:ext cx="38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 flipH="1">
              <a:off x="1554120" y="1335240"/>
              <a:ext cx="76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1390680" y="1268280"/>
              <a:ext cx="2034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0.1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 flipH="1">
              <a:off x="1592280" y="1535040"/>
              <a:ext cx="38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 flipH="1">
              <a:off x="1592280" y="1725480"/>
              <a:ext cx="38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 flipH="1">
              <a:off x="1592280" y="1924200"/>
              <a:ext cx="38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 flipH="1">
              <a:off x="1592280" y="2114640"/>
              <a:ext cx="38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5710320" y="2981160"/>
              <a:ext cx="57240" cy="57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5757480" y="2857680"/>
              <a:ext cx="381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Arian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4097160" y="3276720"/>
              <a:ext cx="57240" cy="568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480" bIns="-6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4646520" y="3205080"/>
              <a:ext cx="430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Atlanti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5416560" y="3618000"/>
              <a:ext cx="57240" cy="57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5464080" y="3494160"/>
              <a:ext cx="409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Aureli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4514760" y="3133800"/>
              <a:ext cx="93600" cy="936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440" bIns="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4561560" y="3060720"/>
              <a:ext cx="430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Claudi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4419720" y="3057480"/>
              <a:ext cx="56880" cy="57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4467240" y="2924280"/>
              <a:ext cx="325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Forti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3765600" y="3267000"/>
              <a:ext cx="57240" cy="57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3790440" y="3098880"/>
              <a:ext cx="288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Opu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4457880" y="3038400"/>
              <a:ext cx="56880" cy="57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4856040" y="2914560"/>
              <a:ext cx="50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Princes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3765600" y="3009960"/>
              <a:ext cx="57240" cy="57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3812760" y="2886120"/>
              <a:ext cx="311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Rave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3727440" y="2695680"/>
              <a:ext cx="57240" cy="568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480" bIns="-6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3775320" y="2533680"/>
              <a:ext cx="494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Sylveste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4068720" y="3000240"/>
              <a:ext cx="57240" cy="57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4339080" y="284328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Winne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3963960" y="2790720"/>
              <a:ext cx="57240" cy="57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4010760" y="2666880"/>
              <a:ext cx="348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A810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3090960" y="1687680"/>
              <a:ext cx="56880" cy="568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480" bIns="-6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3137400" y="1563840"/>
              <a:ext cx="418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301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3822840" y="2610000"/>
              <a:ext cx="56880" cy="568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480" bIns="-6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3868560" y="2413080"/>
              <a:ext cx="419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H6637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3584520" y="2762280"/>
              <a:ext cx="57240" cy="57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3347280" y="2638440"/>
              <a:ext cx="474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HM543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7477200" y="3295800"/>
              <a:ext cx="90360" cy="936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440" bIns="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7521840" y="3171960"/>
              <a:ext cx="552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KWS812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3879720" y="3200400"/>
              <a:ext cx="55800" cy="57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4065480" y="3068640"/>
              <a:ext cx="419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H6641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4352760" y="2590920"/>
              <a:ext cx="93960" cy="936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440" bIns="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4399200" y="2455920"/>
              <a:ext cx="404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HI003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6091200" y="3389400"/>
              <a:ext cx="57240" cy="57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6137280" y="3267000"/>
              <a:ext cx="552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KWS922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2692440" y="2981160"/>
              <a:ext cx="57240" cy="57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2739240" y="2857680"/>
              <a:ext cx="474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MK990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3176640" y="2714760"/>
              <a:ext cx="57240" cy="568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480" bIns="-6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3222720" y="2771640"/>
              <a:ext cx="326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S19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4476600" y="3228840"/>
              <a:ext cx="93960" cy="939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4413600" y="3314880"/>
              <a:ext cx="339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Arist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3973680" y="2943360"/>
              <a:ext cx="56880" cy="568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480" bIns="-6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4021920" y="277020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Assis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6802560" y="2571840"/>
              <a:ext cx="93600" cy="936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440" bIns="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6849720" y="2448000"/>
              <a:ext cx="424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Brigitt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3794040" y="3267000"/>
              <a:ext cx="57240" cy="57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3842640" y="3298680"/>
              <a:ext cx="473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Carame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3992400" y="2552760"/>
              <a:ext cx="57240" cy="57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4039560" y="2276640"/>
              <a:ext cx="438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Cynthi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3613320" y="3029040"/>
              <a:ext cx="56880" cy="57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3276360" y="2905200"/>
              <a:ext cx="450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Helsink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6442200" y="1306440"/>
              <a:ext cx="93600" cy="936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440" bIns="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6489720" y="1182600"/>
              <a:ext cx="39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Lenor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5027760" y="4151160"/>
              <a:ext cx="93600" cy="939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5074560" y="4027320"/>
              <a:ext cx="522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Madonn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2568600" y="1544760"/>
              <a:ext cx="93600" cy="936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440" bIns="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2616840" y="1420920"/>
              <a:ext cx="323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Nemi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3841920" y="3019320"/>
              <a:ext cx="56880" cy="57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3634560" y="2770200"/>
              <a:ext cx="247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Osl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5796000" y="3703680"/>
              <a:ext cx="93600" cy="936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440" bIns="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5844600" y="3579840"/>
              <a:ext cx="451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Rebecc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6232680" y="3427560"/>
              <a:ext cx="56880" cy="568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480" bIns="-6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6279840" y="3382920"/>
              <a:ext cx="303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Tiar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3195720" y="2657520"/>
              <a:ext cx="57240" cy="57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2904840" y="2522520"/>
              <a:ext cx="374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Toled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4087800" y="3238560"/>
              <a:ext cx="57240" cy="57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4135320" y="3421080"/>
              <a:ext cx="401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Winso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2720880" y="2752560"/>
              <a:ext cx="57240" cy="57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2524680" y="2629080"/>
              <a:ext cx="512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Blenhei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3166920" y="3200400"/>
              <a:ext cx="93960" cy="936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440" bIns="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3260160" y="3224160"/>
              <a:ext cx="416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Cresto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3328920" y="2565360"/>
              <a:ext cx="57240" cy="57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3375360" y="2421000"/>
              <a:ext cx="418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30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3954600" y="2752560"/>
              <a:ext cx="56880" cy="57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4495680" y="2629080"/>
              <a:ext cx="509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Lion990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3935520" y="3124080"/>
              <a:ext cx="56880" cy="57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3284640" y="3078000"/>
              <a:ext cx="509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Lion99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1601640" y="5216400"/>
              <a:ext cx="90720" cy="939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1646640" y="5092560"/>
              <a:ext cx="49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Stru20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13T14:43:32Z</dcterms:created>
  <dc:creator>smuld001</dc:creator>
  <dc:description/>
  <dc:language>en-US</dc:language>
  <cp:lastModifiedBy>smuld001</cp:lastModifiedBy>
  <dcterms:modified xsi:type="dcterms:W3CDTF">2010-04-13T14:59:40Z</dcterms:modified>
  <cp:revision>2</cp:revision>
  <dc:subject/>
  <dc:title>Slide 1</dc:title>
</cp:coreProperties>
</file>